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ED624-E919-44C4-8FCF-849A83F071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C6170-7D3D-4EA6-8EE6-F95982AE6C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31F81-AF49-4083-945C-AA9776B8A9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41C83-C5A8-490A-BDE9-3643957B03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D8987-5818-435C-BADB-6652A44E6E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E4386-96A3-4405-B178-2684C1E18F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4784C-07D9-4CFA-A681-F32877B391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AB089-8A9C-452A-88FA-10F9B23F49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E433F-326D-4509-9016-4B040D8374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97D97-ED19-4A4A-8DBB-D1E3B0D6A5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41CC0-4EF3-4A6D-BA39-5AE9673C1F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ACBFB-0103-4BA8-9A7C-50ACCB107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917D29-C789-498C-82C9-FC98BD2A62E6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93600" y="87480"/>
            <a:ext cx="12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400" spc="-1" strike="noStrike">
                <a:solidFill>
                  <a:srgbClr val="000000"/>
                </a:solidFill>
                <a:latin typeface="Arial"/>
              </a:rPr>
              <a:t>Figure S4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4" descr="C:\Users\dv6\Desktop\venn.tif"/>
          <p:cNvPicPr/>
          <p:nvPr/>
        </p:nvPicPr>
        <p:blipFill>
          <a:blip r:embed="rId1"/>
          <a:stretch/>
        </p:blipFill>
        <p:spPr>
          <a:xfrm>
            <a:off x="915840" y="992160"/>
            <a:ext cx="4313520" cy="559764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1"/>
          <p:cNvSpPr/>
          <p:nvPr/>
        </p:nvSpPr>
        <p:spPr>
          <a:xfrm>
            <a:off x="1125360" y="87480"/>
            <a:ext cx="5543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mparison of IGFBP2 regulated genes in knock down cells with other available data set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4T16:28:33Z</dcterms:created>
  <dc:creator>dv6</dc:creator>
  <dc:description/>
  <dc:language>en-US</dc:language>
  <cp:lastModifiedBy>dv6</cp:lastModifiedBy>
  <dcterms:modified xsi:type="dcterms:W3CDTF">2013-04-25T11:42:15Z</dcterms:modified>
  <cp:revision>5</cp:revision>
  <dc:subject/>
  <dc:title>PowerPoint Presentation</dc:title>
</cp:coreProperties>
</file>